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5" r:id="rId3"/>
    <p:sldId id="26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608" autoAdjust="0"/>
    <p:restoredTop sz="94694"/>
  </p:normalViewPr>
  <p:slideViewPr>
    <p:cSldViewPr snapToGrid="0">
      <p:cViewPr varScale="1">
        <p:scale>
          <a:sx n="117" d="100"/>
          <a:sy n="117" d="100"/>
        </p:scale>
        <p:origin x="8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EA442F-0254-41DF-BA0B-5FAA6BF28180}" type="datetimeFigureOut">
              <a:rPr lang="en-US" smtClean="0"/>
              <a:t>8/2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19990B-E2FE-4908-8E37-DB246F82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24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19990B-E2FE-4908-8E37-DB246F82A7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0298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19990B-E2FE-4908-8E37-DB246F82A78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0099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19990B-E2FE-4908-8E37-DB246F82A78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2562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05DFE-0EF5-7353-AB12-10D1053FDA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FB5106-701D-0D7E-7FAF-A70CBBA63C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36C95D-820A-82ED-DF47-64B0BB21B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9FDD50-8ADF-6301-7426-046E9ACC2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742A73-C643-89F1-01F8-37E1D6658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626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1B704-BBB0-E46A-BEEE-CC0B4CA1AA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9DC728-0165-D350-87FB-16F55F8CCE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EC772-1C3F-1701-29D7-A514B074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E2671C-784C-B5FC-84E2-CF92C256F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AEE9AD-23D4-74BF-68E3-89F2A7FE0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032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73F970-79BC-818E-9920-C93B294274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43D923-1CAA-9B05-BB9E-EDAC4EC674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0AB36-E1B9-930F-9121-468257D45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B6BBAF-5625-A215-33B1-1E8452B54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1BA132-7F10-7A5B-48FE-1E02BF459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15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7D824-DFE4-4D3E-5195-08F7C9DFC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780A53-4B1F-5EF1-6B0A-335856B21F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D63891-0C14-B5CE-5EB9-02BF0EA5A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7269E6-9CE6-9F77-6F99-8A46832C2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051C17-B5A7-ED4E-E2AF-D63DF3D38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263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7DA9F-3B0D-3463-D74F-697BB153B3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557684-5765-43DA-A542-FFE9F581C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CD3D0-4E3A-EA59-60FE-2F49EF450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DFC9D7-653F-61A3-2D79-AB83F3B8B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CA29AC-2E39-700C-6F25-AB0FA7A49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543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48998-7FFC-C96E-76E9-53CDDEE72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75F5E7-F658-C042-38AF-308D32A1C4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483852-B297-1A9B-DBB0-8E3E8ED7C5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13ECCD-8BA8-2594-8429-804B5A56E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DD4DF3-E5B6-E2AB-F213-68084D53E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7C6ECE-5502-1779-D1F2-0F35FCF27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40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70306-F5A1-0743-330C-C159160CE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738E50-A142-DCB4-9CC0-46AEF94D2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7C5242-4D6A-053B-FE23-C820EF55EC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36BB0F6-6D98-AB8D-DFCE-793B41C605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909EB7-269F-AF9B-933A-2C3D6A4486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9EF19CF-3841-E1F8-6AE7-B37438A87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4CA75D-502E-0D40-9680-6C507E900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0B12EF-F17A-8ED1-E9D7-75FF99F08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425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2897E-06DC-EE7A-0325-8C0410BCC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27CAA5-9C47-6B03-AA3D-F53FBA757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765EC8-0A09-6AB0-6437-A765E43C2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DCED03-40BF-64F5-7AE8-72B9C77EB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227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7E448F-4A7A-D46C-E166-821F1FABD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ACC51CC-D844-4350-196B-73DA95177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5039B6-B1B1-4B82-2948-B1FAF14DD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41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18E02-9C88-5614-349A-3F7829A3F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3009A9-246E-3C70-9022-4FE7BE360E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DA3ED1-DDD0-E12C-F1AE-4B197565E6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CCF207-6961-CD8F-7EF7-B41B13933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C99549-673A-CB89-E30B-CBE8D23504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D1F699-8821-3278-06B6-DB3987DC6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519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DD0BC3-EFD9-D50C-3D2D-4D82842A48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AB60CC-8A94-2279-58DC-F058222871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C91797-9473-CB70-0CEE-47CF7169DA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E718C1-FF74-90C4-2372-93A303319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6082B6-149E-AEE7-8EBA-DC254D4E0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E9A63B-6DC9-D624-A33D-EE3EDCC01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07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7167F9-633F-5904-993D-E7EFB8202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B30458-06B4-D159-4CA5-B8515B57E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D2A78-FD98-D1CA-6B15-91AD33B843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3DCD9-262B-95A9-FD3E-F3E461528B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3AF47E-DED6-BCE2-6038-63E850A129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308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1A6BB5D-D624-0075-E7C2-1EB340C4E18D}"/>
              </a:ext>
            </a:extLst>
          </p:cNvPr>
          <p:cNvSpPr txBox="1"/>
          <p:nvPr/>
        </p:nvSpPr>
        <p:spPr>
          <a:xfrm>
            <a:off x="96981" y="110836"/>
            <a:ext cx="4628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– MYC Skeletal Muscle Gel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3B428C8-B83F-2822-CCA4-926AF96720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4799" y="1883121"/>
            <a:ext cx="4803793" cy="309175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2C2BD01-DEF1-688B-75B7-BD4A791A6BC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894" t="30572" r="63637" b="36297"/>
          <a:stretch/>
        </p:blipFill>
        <p:spPr>
          <a:xfrm>
            <a:off x="6378592" y="1883121"/>
            <a:ext cx="4888999" cy="3091758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D896BDD-E441-E86E-48E3-FF320B3721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4286020"/>
              </p:ext>
            </p:extLst>
          </p:nvPr>
        </p:nvGraphicFramePr>
        <p:xfrm>
          <a:off x="7224666" y="4974879"/>
          <a:ext cx="4024819" cy="12154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1793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98761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89752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73265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315305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94285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62755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83833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315247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273265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52244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294285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283775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346254">
                  <a:extLst>
                    <a:ext uri="{9D8B030D-6E8A-4147-A177-3AD203B41FA5}">
                      <a16:colId xmlns:a16="http://schemas.microsoft.com/office/drawing/2014/main" val="126020196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AFB54BC9-5198-9EE4-D7A6-F32477A387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931797"/>
              </p:ext>
            </p:extLst>
          </p:nvPr>
        </p:nvGraphicFramePr>
        <p:xfrm>
          <a:off x="2518738" y="4974879"/>
          <a:ext cx="3678859" cy="12154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1010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73080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64846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49776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288202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68989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40170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59435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288150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249776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30562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268989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259383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316491">
                  <a:extLst>
                    <a:ext uri="{9D8B030D-6E8A-4147-A177-3AD203B41FA5}">
                      <a16:colId xmlns:a16="http://schemas.microsoft.com/office/drawing/2014/main" val="126020196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8E4AC37D-D861-91A3-14E1-EBE5FA8D1543}"/>
              </a:ext>
            </a:extLst>
          </p:cNvPr>
          <p:cNvSpPr txBox="1"/>
          <p:nvPr/>
        </p:nvSpPr>
        <p:spPr>
          <a:xfrm>
            <a:off x="8930739" y="273170"/>
            <a:ext cx="307319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=Control</a:t>
            </a:r>
          </a:p>
          <a:p>
            <a:r>
              <a:rPr lang="en-US" sz="1100" dirty="0"/>
              <a:t>SOL=Soleus</a:t>
            </a:r>
            <a:br>
              <a:rPr lang="en-US" sz="1100" dirty="0"/>
            </a:br>
            <a:r>
              <a:rPr lang="en-US" sz="1100" dirty="0"/>
              <a:t>GAS=Gastrocnemius</a:t>
            </a:r>
          </a:p>
          <a:p>
            <a:r>
              <a:rPr lang="en-US" sz="1100" dirty="0"/>
              <a:t>TA=Tibialis Anterior</a:t>
            </a:r>
            <a:br>
              <a:rPr lang="en-US" sz="1100" dirty="0"/>
            </a:br>
            <a:r>
              <a:rPr lang="en-US" sz="1100" dirty="0"/>
              <a:t>PLANT=Plantaris</a:t>
            </a:r>
          </a:p>
          <a:p>
            <a:r>
              <a:rPr lang="en-US" sz="1100" dirty="0"/>
              <a:t>IC=Internal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2A75861-E7E0-0B1A-9782-CA959ECCADE3}"/>
              </a:ext>
            </a:extLst>
          </p:cNvPr>
          <p:cNvSpPr txBox="1"/>
          <p:nvPr/>
        </p:nvSpPr>
        <p:spPr>
          <a:xfrm>
            <a:off x="833367" y="1970880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AEBC9D-B1C0-69D6-4192-3B39879C40AF}"/>
              </a:ext>
            </a:extLst>
          </p:cNvPr>
          <p:cNvSpPr txBox="1"/>
          <p:nvPr/>
        </p:nvSpPr>
        <p:spPr>
          <a:xfrm>
            <a:off x="833367" y="2175161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3B17D8-40A5-8C13-B6A7-202DA44B0152}"/>
              </a:ext>
            </a:extLst>
          </p:cNvPr>
          <p:cNvSpPr txBox="1"/>
          <p:nvPr/>
        </p:nvSpPr>
        <p:spPr>
          <a:xfrm>
            <a:off x="833367" y="2379442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0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36FA14-2EF2-888F-256E-F10EF6CEC99A}"/>
              </a:ext>
            </a:extLst>
          </p:cNvPr>
          <p:cNvSpPr txBox="1"/>
          <p:nvPr/>
        </p:nvSpPr>
        <p:spPr>
          <a:xfrm>
            <a:off x="833367" y="2975555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375B369-8971-C199-EF2C-CB66C6EFB52A}"/>
              </a:ext>
            </a:extLst>
          </p:cNvPr>
          <p:cNvSpPr txBox="1"/>
          <p:nvPr/>
        </p:nvSpPr>
        <p:spPr>
          <a:xfrm>
            <a:off x="833367" y="2520900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7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841C30E-1829-77C0-F61A-1CD781791573}"/>
              </a:ext>
            </a:extLst>
          </p:cNvPr>
          <p:cNvSpPr txBox="1"/>
          <p:nvPr/>
        </p:nvSpPr>
        <p:spPr>
          <a:xfrm>
            <a:off x="833367" y="3446684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37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7DC5A2A-0FFA-526B-031A-DBB0AEBA3CC5}"/>
              </a:ext>
            </a:extLst>
          </p:cNvPr>
          <p:cNvSpPr txBox="1"/>
          <p:nvPr/>
        </p:nvSpPr>
        <p:spPr>
          <a:xfrm>
            <a:off x="833367" y="3978125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2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9CD2B94-B95C-2138-5980-154B1AAEFD4E}"/>
              </a:ext>
            </a:extLst>
          </p:cNvPr>
          <p:cNvSpPr txBox="1"/>
          <p:nvPr/>
        </p:nvSpPr>
        <p:spPr>
          <a:xfrm>
            <a:off x="833367" y="4239735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A65C70D-D4FD-565F-2DC8-0DE1B7C2A113}"/>
              </a:ext>
            </a:extLst>
          </p:cNvPr>
          <p:cNvSpPr txBox="1"/>
          <p:nvPr/>
        </p:nvSpPr>
        <p:spPr>
          <a:xfrm>
            <a:off x="833367" y="4479206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5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000561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1A6BB5D-D624-0075-E7C2-1EB340C4E18D}"/>
              </a:ext>
            </a:extLst>
          </p:cNvPr>
          <p:cNvSpPr txBox="1"/>
          <p:nvPr/>
        </p:nvSpPr>
        <p:spPr>
          <a:xfrm>
            <a:off x="96981" y="110836"/>
            <a:ext cx="4628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– MYC Skeletal Muscle Gel 2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ABABCC2-D9EA-5C25-07E8-79B0B7A8C6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7017" y="1883121"/>
            <a:ext cx="4803793" cy="309175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F8FFC13-BDB0-658C-C9B8-50CBB529C7C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348" t="25051" r="62955" b="41279"/>
          <a:stretch/>
        </p:blipFill>
        <p:spPr>
          <a:xfrm>
            <a:off x="6317672" y="1883121"/>
            <a:ext cx="4847877" cy="3091758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0A53FFCE-9D54-249E-F2C4-2632925EA6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03184"/>
              </p:ext>
            </p:extLst>
          </p:nvPr>
        </p:nvGraphicFramePr>
        <p:xfrm>
          <a:off x="2374500" y="4974879"/>
          <a:ext cx="3684556" cy="12154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1352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73503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65257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50163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288649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69405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40541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59838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288596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250163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30919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269405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259784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316981">
                  <a:extLst>
                    <a:ext uri="{9D8B030D-6E8A-4147-A177-3AD203B41FA5}">
                      <a16:colId xmlns:a16="http://schemas.microsoft.com/office/drawing/2014/main" val="126020196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C07FBA71-5868-5E69-E1D2-FFEEF7E053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7770694"/>
              </p:ext>
            </p:extLst>
          </p:nvPr>
        </p:nvGraphicFramePr>
        <p:xfrm>
          <a:off x="7196765" y="4974879"/>
          <a:ext cx="3896104" cy="12154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4061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89206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80487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64526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305222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84873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54351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74757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305166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264526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44177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284873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274699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335180">
                  <a:extLst>
                    <a:ext uri="{9D8B030D-6E8A-4147-A177-3AD203B41FA5}">
                      <a16:colId xmlns:a16="http://schemas.microsoft.com/office/drawing/2014/main" val="126020196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2656FD2-5BE9-A6E5-4FE2-245AE5F41BBC}"/>
              </a:ext>
            </a:extLst>
          </p:cNvPr>
          <p:cNvSpPr txBox="1"/>
          <p:nvPr/>
        </p:nvSpPr>
        <p:spPr>
          <a:xfrm>
            <a:off x="8930739" y="273170"/>
            <a:ext cx="307319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=Control</a:t>
            </a:r>
          </a:p>
          <a:p>
            <a:r>
              <a:rPr lang="en-US" sz="1100" dirty="0"/>
              <a:t>SOL=Soleus</a:t>
            </a:r>
            <a:br>
              <a:rPr lang="en-US" sz="1100" dirty="0"/>
            </a:br>
            <a:r>
              <a:rPr lang="en-US" sz="1100" dirty="0"/>
              <a:t>GAS=Gastrocnemius</a:t>
            </a:r>
          </a:p>
          <a:p>
            <a:r>
              <a:rPr lang="en-US" sz="1100" dirty="0"/>
              <a:t>TA=Tibialis Anterior</a:t>
            </a:r>
            <a:br>
              <a:rPr lang="en-US" sz="1100" dirty="0"/>
            </a:br>
            <a:r>
              <a:rPr lang="en-US" sz="1100" dirty="0"/>
              <a:t>PLANT=Plantaris</a:t>
            </a:r>
          </a:p>
          <a:p>
            <a:r>
              <a:rPr lang="en-US" sz="1100" dirty="0"/>
              <a:t>IC=Internal 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DD5291-29E3-AD9B-1434-BC9AF40D0532}"/>
              </a:ext>
            </a:extLst>
          </p:cNvPr>
          <p:cNvSpPr txBox="1"/>
          <p:nvPr/>
        </p:nvSpPr>
        <p:spPr>
          <a:xfrm>
            <a:off x="829511" y="2145051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4E55BD-4B10-8E19-E102-1644A8908676}"/>
              </a:ext>
            </a:extLst>
          </p:cNvPr>
          <p:cNvSpPr txBox="1"/>
          <p:nvPr/>
        </p:nvSpPr>
        <p:spPr>
          <a:xfrm>
            <a:off x="829511" y="2349332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CBB1062-6A7A-825A-E40A-A6765C8332F9}"/>
              </a:ext>
            </a:extLst>
          </p:cNvPr>
          <p:cNvSpPr txBox="1"/>
          <p:nvPr/>
        </p:nvSpPr>
        <p:spPr>
          <a:xfrm>
            <a:off x="829511" y="2553613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0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9E7028-534C-0D0A-791D-AFFE6A46B81C}"/>
              </a:ext>
            </a:extLst>
          </p:cNvPr>
          <p:cNvSpPr txBox="1"/>
          <p:nvPr/>
        </p:nvSpPr>
        <p:spPr>
          <a:xfrm>
            <a:off x="829511" y="3149726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CD6BD5D-E735-2749-C30E-08916DFF4AC8}"/>
              </a:ext>
            </a:extLst>
          </p:cNvPr>
          <p:cNvSpPr txBox="1"/>
          <p:nvPr/>
        </p:nvSpPr>
        <p:spPr>
          <a:xfrm>
            <a:off x="829511" y="2695071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7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54A9771-7F06-7DDA-53C7-BA6D5CDE4C8E}"/>
              </a:ext>
            </a:extLst>
          </p:cNvPr>
          <p:cNvSpPr txBox="1"/>
          <p:nvPr/>
        </p:nvSpPr>
        <p:spPr>
          <a:xfrm>
            <a:off x="829511" y="3620855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37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CF95A43-FF37-1EBF-3492-B79FBCD518EE}"/>
              </a:ext>
            </a:extLst>
          </p:cNvPr>
          <p:cNvSpPr txBox="1"/>
          <p:nvPr/>
        </p:nvSpPr>
        <p:spPr>
          <a:xfrm>
            <a:off x="829511" y="4152296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2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B79036-AC91-48A0-ADE9-4397556365EB}"/>
              </a:ext>
            </a:extLst>
          </p:cNvPr>
          <p:cNvSpPr txBox="1"/>
          <p:nvPr/>
        </p:nvSpPr>
        <p:spPr>
          <a:xfrm>
            <a:off x="829511" y="4413906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C422FD9-92DD-8DD8-2593-5F197D3B93D9}"/>
              </a:ext>
            </a:extLst>
          </p:cNvPr>
          <p:cNvSpPr txBox="1"/>
          <p:nvPr/>
        </p:nvSpPr>
        <p:spPr>
          <a:xfrm>
            <a:off x="829511" y="4653377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5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78494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1A6BB5D-D624-0075-E7C2-1EB340C4E18D}"/>
              </a:ext>
            </a:extLst>
          </p:cNvPr>
          <p:cNvSpPr txBox="1"/>
          <p:nvPr/>
        </p:nvSpPr>
        <p:spPr>
          <a:xfrm>
            <a:off x="96981" y="110836"/>
            <a:ext cx="4628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– MYC Skeletal Muscle Gel 3 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0A53FFCE-9D54-249E-F2C4-2632925EA632}"/>
              </a:ext>
            </a:extLst>
          </p:cNvPr>
          <p:cNvGraphicFramePr>
            <a:graphicFrameLocks noGrp="1"/>
          </p:cNvGraphicFramePr>
          <p:nvPr/>
        </p:nvGraphicFramePr>
        <p:xfrm>
          <a:off x="2374500" y="4974879"/>
          <a:ext cx="3684556" cy="12154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1352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73503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65257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50163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288649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69405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40541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59838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288596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250163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30919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269405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259784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316981">
                  <a:extLst>
                    <a:ext uri="{9D8B030D-6E8A-4147-A177-3AD203B41FA5}">
                      <a16:colId xmlns:a16="http://schemas.microsoft.com/office/drawing/2014/main" val="126020196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C07FBA71-5868-5E69-E1D2-FFEEF7E053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8538685"/>
              </p:ext>
            </p:extLst>
          </p:nvPr>
        </p:nvGraphicFramePr>
        <p:xfrm>
          <a:off x="7546647" y="4958350"/>
          <a:ext cx="3784085" cy="12154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7331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80891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72423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56921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296446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76682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47038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66857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296392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256921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45967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312160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222513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325543">
                  <a:extLst>
                    <a:ext uri="{9D8B030D-6E8A-4147-A177-3AD203B41FA5}">
                      <a16:colId xmlns:a16="http://schemas.microsoft.com/office/drawing/2014/main" val="126020196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  <a:p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8CD36A5A-02BC-0FC1-97CA-25862E22BE6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712" b="2896"/>
          <a:stretch/>
        </p:blipFill>
        <p:spPr>
          <a:xfrm>
            <a:off x="1371325" y="2110509"/>
            <a:ext cx="4817039" cy="286437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38E42A1-56A4-3BA2-9ABB-0F821929656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386" t="27459" r="54266" b="35218"/>
          <a:stretch/>
        </p:blipFill>
        <p:spPr>
          <a:xfrm>
            <a:off x="6459373" y="2087631"/>
            <a:ext cx="4817039" cy="291012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046AD2D-7E22-1653-0AEF-8400BADA8EED}"/>
              </a:ext>
            </a:extLst>
          </p:cNvPr>
          <p:cNvSpPr txBox="1"/>
          <p:nvPr/>
        </p:nvSpPr>
        <p:spPr>
          <a:xfrm>
            <a:off x="8930739" y="273170"/>
            <a:ext cx="307319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=Control</a:t>
            </a:r>
          </a:p>
          <a:p>
            <a:r>
              <a:rPr lang="en-US" sz="1100" dirty="0"/>
              <a:t>SOL=Soleus</a:t>
            </a:r>
            <a:br>
              <a:rPr lang="en-US" sz="1100" dirty="0"/>
            </a:br>
            <a:r>
              <a:rPr lang="en-US" sz="1100" dirty="0"/>
              <a:t>GAS=Gastrocnemius</a:t>
            </a:r>
          </a:p>
          <a:p>
            <a:r>
              <a:rPr lang="en-US" sz="1100" dirty="0"/>
              <a:t>TA=Tibialis Anterior</a:t>
            </a:r>
            <a:br>
              <a:rPr lang="en-US" sz="1100" dirty="0"/>
            </a:br>
            <a:r>
              <a:rPr lang="en-US" sz="1100" dirty="0"/>
              <a:t>PLANT=Plantaris</a:t>
            </a:r>
          </a:p>
          <a:p>
            <a:r>
              <a:rPr lang="en-US" sz="1100" dirty="0"/>
              <a:t>IC=Internal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4DE79D-36F8-0F39-8E79-F1F85DAD95B9}"/>
              </a:ext>
            </a:extLst>
          </p:cNvPr>
          <p:cNvSpPr txBox="1"/>
          <p:nvPr/>
        </p:nvSpPr>
        <p:spPr>
          <a:xfrm>
            <a:off x="731769" y="2110509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FF56B54-01ED-3D8E-2340-BB08B7C6D94E}"/>
              </a:ext>
            </a:extLst>
          </p:cNvPr>
          <p:cNvSpPr txBox="1"/>
          <p:nvPr/>
        </p:nvSpPr>
        <p:spPr>
          <a:xfrm>
            <a:off x="731769" y="2314790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3DEACA7-8428-7625-CE34-E5E9660188D1}"/>
              </a:ext>
            </a:extLst>
          </p:cNvPr>
          <p:cNvSpPr txBox="1"/>
          <p:nvPr/>
        </p:nvSpPr>
        <p:spPr>
          <a:xfrm>
            <a:off x="731769" y="2519071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0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01060B-181F-FE20-90C9-4CE4E529FA42}"/>
              </a:ext>
            </a:extLst>
          </p:cNvPr>
          <p:cNvSpPr txBox="1"/>
          <p:nvPr/>
        </p:nvSpPr>
        <p:spPr>
          <a:xfrm>
            <a:off x="731769" y="2991815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397F7F-6336-430A-C2D7-5B6D61FF2108}"/>
              </a:ext>
            </a:extLst>
          </p:cNvPr>
          <p:cNvSpPr txBox="1"/>
          <p:nvPr/>
        </p:nvSpPr>
        <p:spPr>
          <a:xfrm>
            <a:off x="731769" y="2660529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7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31812AF-2DF3-F1A9-253D-09201D5A6A61}"/>
              </a:ext>
            </a:extLst>
          </p:cNvPr>
          <p:cNvSpPr txBox="1"/>
          <p:nvPr/>
        </p:nvSpPr>
        <p:spPr>
          <a:xfrm>
            <a:off x="731769" y="3325061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37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48CE377-26D6-1B5D-D47F-228A015E52E1}"/>
              </a:ext>
            </a:extLst>
          </p:cNvPr>
          <p:cNvSpPr txBox="1"/>
          <p:nvPr/>
        </p:nvSpPr>
        <p:spPr>
          <a:xfrm>
            <a:off x="731769" y="3769411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2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147768-07B3-F506-0BD1-7E5E2DC919DD}"/>
              </a:ext>
            </a:extLst>
          </p:cNvPr>
          <p:cNvSpPr txBox="1"/>
          <p:nvPr/>
        </p:nvSpPr>
        <p:spPr>
          <a:xfrm>
            <a:off x="731769" y="3965708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90C3A2-9844-8541-DB8B-E4E1C88315BB}"/>
              </a:ext>
            </a:extLst>
          </p:cNvPr>
          <p:cNvSpPr txBox="1"/>
          <p:nvPr/>
        </p:nvSpPr>
        <p:spPr>
          <a:xfrm>
            <a:off x="731769" y="4147123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5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513A972E-0379-F7B5-12CD-B68127582726}"/>
              </a:ext>
            </a:extLst>
          </p:cNvPr>
          <p:cNvSpPr/>
          <p:nvPr/>
        </p:nvSpPr>
        <p:spPr>
          <a:xfrm rot="21480000">
            <a:off x="2344040" y="2921463"/>
            <a:ext cx="3066638" cy="717109"/>
          </a:xfrm>
          <a:prstGeom prst="rect">
            <a:avLst/>
          </a:prstGeom>
          <a:noFill/>
          <a:ln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DD06182-0FE2-BBE1-A9B6-EF3B1E016376}"/>
              </a:ext>
            </a:extLst>
          </p:cNvPr>
          <p:cNvSpPr/>
          <p:nvPr/>
        </p:nvSpPr>
        <p:spPr>
          <a:xfrm rot="21360000">
            <a:off x="7466714" y="2897333"/>
            <a:ext cx="3207931" cy="296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234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327</Words>
  <Application>Microsoft Macintosh PowerPoint</Application>
  <PresentationFormat>Widescreen</PresentationFormat>
  <Paragraphs>297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in Khadgi</dc:creator>
  <cp:lastModifiedBy>Sebastian Edman</cp:lastModifiedBy>
  <cp:revision>14</cp:revision>
  <dcterms:created xsi:type="dcterms:W3CDTF">2024-03-15T18:36:29Z</dcterms:created>
  <dcterms:modified xsi:type="dcterms:W3CDTF">2024-08-28T11:20:22Z</dcterms:modified>
</cp:coreProperties>
</file>